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8"/>
  </p:normalViewPr>
  <p:slideViewPr>
    <p:cSldViewPr snapToGrid="0" snapToObjects="1">
      <p:cViewPr varScale="1">
        <p:scale>
          <a:sx n="109" d="100"/>
          <a:sy n="109" d="100"/>
        </p:scale>
        <p:origin x="6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0C92F03-A3BF-484A-8EE6-9207A107AA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61B3E02C-838F-9E4B-BDEA-FD2B34AEE6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A3ACBA8-BA7F-8E45-8AAC-A7516456E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F41929F-A191-0141-91EA-0F33058FA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61110812-D674-FA4F-9CA8-FFD88AFCC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45719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DFE8F73-7A87-3646-963B-DCB7FC055C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E433713F-6826-7741-896D-4449275433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D6616DA-6211-1142-840F-6CC24C128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42583C2-FCEF-DB40-9CD6-B8911D84C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F8EE7CC-0AE1-5043-8D02-9366DA4FD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99185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1EE93461-0420-7D40-90CC-4DE32E80AE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8E023761-CBFB-5E49-B898-D95572A6FE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E7CE133-520A-DC47-9D4D-06DA815F1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8AF9C5D-6F1C-B944-B0D6-7CAFBD240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3652EFBD-882A-A540-8893-835825B4F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63593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DFE80AA-8251-F646-BC62-3E0A05535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E1D801E5-9A77-9A43-B6F7-F9C70B2627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605DD08-DA61-2A4F-BF85-8D0F6CDB4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CC748A0-D396-4045-8204-6DB6A09D2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8E888512-4551-444B-B6B9-2148BA617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7845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AC4EEDF-CB3B-E14B-8EC9-E62C06BEE1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D3E98C12-A4D9-CC44-B895-F4A07DBA2A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E8D338C-1CCB-9944-B5D2-E33A8CBE1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ECEB7B9-FB95-8B44-8E24-59D46383C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E741C61-DCE8-E049-BA1C-EE7F0BD24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0190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61E6059-521A-FA4C-ADAB-C6E7CE4C66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38AA886A-A132-EC4D-B28B-A689CDC430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05176ACE-7E71-C544-9A9C-00B5D45D09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EFDE1F32-2549-C642-A9E4-1C9C42A15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581D3D47-91B3-2148-89F8-6368417A1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67ED5E66-189D-3949-A304-ADCB3FD2A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74469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C55760A-3372-9E49-B6EF-13EA474B71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F676D23E-AD32-844B-A031-6EBBAF715A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56E838B8-BA20-6C41-9314-06735A35A4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C27CAD48-D0CC-3546-805B-8CC3015DF2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78A45BC1-1DAF-F747-A807-C9185CAB34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BA1A79B2-7D92-804A-B3E4-998CE96F0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4D5C1F59-6D18-3346-943F-723695A91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F0D17782-7ED1-B040-8D58-B52F094FB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25069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00537B4-9198-084C-AC19-503591F8A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476E0794-AB2E-C54F-9FC9-4AE655CDB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D34A43D1-9320-8B43-BDAC-E2ABBA82E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626D7782-9A2D-CB4C-9589-2FE0A0342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26805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261ADA2C-16B2-F645-8803-688F46F39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43A16DC6-FE4B-DA49-970C-5887CAA96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1F53DAE0-98D6-E640-B107-EE19A0BBD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96692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71A9249-57E3-A143-B2E9-36FFECFEB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2C0D935C-6CCC-EB4D-A4A4-0CB372043E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62F5F7F8-3E51-F84B-BD9B-54755F6B9F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2030E88C-B957-154A-B2AF-7A979A75C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6ED27247-BDF2-D841-B64F-08B9DFFA3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609CFD8E-C2F2-CB4B-B5B1-F69232A4D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57198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B56B59C-895A-8548-8E95-74A2CB22BB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2FF2EC32-AB93-5845-B4A3-35361FA2AE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2BC7BF8E-267B-5C42-8BFE-C84CF3E65A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5B797246-DE86-824F-A5A7-FC9B30985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DAE653FF-1B82-7A44-9304-91A77FD8C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1C483F3D-8B66-1044-ABA0-11D967DFF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4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10C08668-10BD-034A-9041-74EA1D343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A3B2578B-BE28-2D4B-902B-7252DDD0E8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CF90B9D-D62A-7B49-B89F-25F2180082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F861D8-B357-234B-B8C9-FD75211E6EF0}" type="datetimeFigureOut">
              <a:rPr lang="sv-SE" smtClean="0"/>
              <a:t>2020-04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C709BA75-04F0-A441-A752-41C922524E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6160C4B-D5AB-DD41-B3B8-7266E99C22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5A2968-958C-B745-9D59-EDF8B8AE3F2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26945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>
            <a:extLst>
              <a:ext uri="{FF2B5EF4-FFF2-40B4-BE49-F238E27FC236}">
                <a16:creationId xmlns:a16="http://schemas.microsoft.com/office/drawing/2014/main" id="{3936306F-F5B9-684B-8C41-6282AAF5C882}"/>
              </a:ext>
            </a:extLst>
          </p:cNvPr>
          <p:cNvSpPr txBox="1"/>
          <p:nvPr/>
        </p:nvSpPr>
        <p:spPr>
          <a:xfrm>
            <a:off x="2951545" y="903080"/>
            <a:ext cx="5856790" cy="1200329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tients referred between January 2009 and December 2018 for evaluation of exertional lower leg pain</a:t>
            </a:r>
          </a:p>
          <a:p>
            <a:endParaRPr lang="en-US" dirty="0">
              <a:effectLst/>
            </a:endParaRPr>
          </a:p>
          <a:p>
            <a:pPr algn="ctr"/>
            <a:r>
              <a:rPr lang="en-US" dirty="0"/>
              <a:t>n= 864 (378 men, 486 women)</a:t>
            </a:r>
          </a:p>
        </p:txBody>
      </p:sp>
      <p:sp>
        <p:nvSpPr>
          <p:cNvPr id="5" name="textruta 4">
            <a:extLst>
              <a:ext uri="{FF2B5EF4-FFF2-40B4-BE49-F238E27FC236}">
                <a16:creationId xmlns:a16="http://schemas.microsoft.com/office/drawing/2014/main" id="{68EEA036-2B81-5E4C-AEF8-5DDDF9D8B2CC}"/>
              </a:ext>
            </a:extLst>
          </p:cNvPr>
          <p:cNvSpPr txBox="1"/>
          <p:nvPr/>
        </p:nvSpPr>
        <p:spPr>
          <a:xfrm>
            <a:off x="1678330" y="4574300"/>
            <a:ext cx="3009418" cy="92333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Patients diagnosed with CECS</a:t>
            </a:r>
          </a:p>
          <a:p>
            <a:endParaRPr lang="en-US" dirty="0"/>
          </a:p>
          <a:p>
            <a:pPr algn="ctr"/>
            <a:r>
              <a:rPr lang="en-US" dirty="0"/>
              <a:t>n=442</a:t>
            </a:r>
          </a:p>
        </p:txBody>
      </p:sp>
      <p:sp>
        <p:nvSpPr>
          <p:cNvPr id="6" name="textruta 5">
            <a:extLst>
              <a:ext uri="{FF2B5EF4-FFF2-40B4-BE49-F238E27FC236}">
                <a16:creationId xmlns:a16="http://schemas.microsoft.com/office/drawing/2014/main" id="{9241B08B-B6D1-C946-B3EC-196A9AB792E8}"/>
              </a:ext>
            </a:extLst>
          </p:cNvPr>
          <p:cNvSpPr txBox="1"/>
          <p:nvPr/>
        </p:nvSpPr>
        <p:spPr>
          <a:xfrm>
            <a:off x="7072132" y="4574300"/>
            <a:ext cx="3865944" cy="92333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Patients in whom CECS was ruled out</a:t>
            </a:r>
          </a:p>
          <a:p>
            <a:endParaRPr lang="en-US" dirty="0"/>
          </a:p>
          <a:p>
            <a:pPr algn="ctr"/>
            <a:r>
              <a:rPr lang="en-US" dirty="0"/>
              <a:t>n=422</a:t>
            </a:r>
          </a:p>
        </p:txBody>
      </p:sp>
      <p:sp>
        <p:nvSpPr>
          <p:cNvPr id="7" name="textruta 6">
            <a:extLst>
              <a:ext uri="{FF2B5EF4-FFF2-40B4-BE49-F238E27FC236}">
                <a16:creationId xmlns:a16="http://schemas.microsoft.com/office/drawing/2014/main" id="{42D3DD62-B710-C348-B26A-207ACD77577F}"/>
              </a:ext>
            </a:extLst>
          </p:cNvPr>
          <p:cNvSpPr txBox="1"/>
          <p:nvPr/>
        </p:nvSpPr>
        <p:spPr>
          <a:xfrm>
            <a:off x="4687748" y="3287196"/>
            <a:ext cx="2384384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MP measurements</a:t>
            </a:r>
          </a:p>
        </p:txBody>
      </p:sp>
      <p:cxnSp>
        <p:nvCxnSpPr>
          <p:cNvPr id="9" name="Rak pil 8">
            <a:extLst>
              <a:ext uri="{FF2B5EF4-FFF2-40B4-BE49-F238E27FC236}">
                <a16:creationId xmlns:a16="http://schemas.microsoft.com/office/drawing/2014/main" id="{D9D0519D-EAEF-B54C-9FDC-EE292AE1FEFD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5879940" y="2103409"/>
            <a:ext cx="0" cy="105412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Rak pil 10">
            <a:extLst>
              <a:ext uri="{FF2B5EF4-FFF2-40B4-BE49-F238E27FC236}">
                <a16:creationId xmlns:a16="http://schemas.microsoft.com/office/drawing/2014/main" id="{1F601032-2CD8-D048-8928-7276DFD404FF}"/>
              </a:ext>
            </a:extLst>
          </p:cNvPr>
          <p:cNvCxnSpPr>
            <a:cxnSpLocks/>
          </p:cNvCxnSpPr>
          <p:nvPr/>
        </p:nvCxnSpPr>
        <p:spPr>
          <a:xfrm>
            <a:off x="6761002" y="3656528"/>
            <a:ext cx="525623" cy="81546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Rak pil 12">
            <a:extLst>
              <a:ext uri="{FF2B5EF4-FFF2-40B4-BE49-F238E27FC236}">
                <a16:creationId xmlns:a16="http://schemas.microsoft.com/office/drawing/2014/main" id="{6B4EA7CE-1F2B-7441-9006-5378CE479FA8}"/>
              </a:ext>
            </a:extLst>
          </p:cNvPr>
          <p:cNvCxnSpPr>
            <a:cxnSpLocks/>
          </p:cNvCxnSpPr>
          <p:nvPr/>
        </p:nvCxnSpPr>
        <p:spPr>
          <a:xfrm flipH="1">
            <a:off x="4374990" y="3656528"/>
            <a:ext cx="539910" cy="81546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11456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4</Words>
  <Application>Microsoft Macintosh PowerPoint</Application>
  <PresentationFormat>Bredbild</PresentationFormat>
  <Paragraphs>10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Sophia Lindorsson</dc:creator>
  <cp:lastModifiedBy>Sophia Lindorsson</cp:lastModifiedBy>
  <cp:revision>5</cp:revision>
  <dcterms:created xsi:type="dcterms:W3CDTF">2020-03-29T14:45:36Z</dcterms:created>
  <dcterms:modified xsi:type="dcterms:W3CDTF">2020-04-21T11:25:05Z</dcterms:modified>
</cp:coreProperties>
</file>